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78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A85AFDC5-AF9C-4F1C-BF93-1CD96CDF22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xmlns="" id="{0E5526F5-AA9B-42C5-8912-22B082CA68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A65CCF8C-C400-404F-87BD-45D62CF35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273D892F-1F38-4931-B2FF-F4E1CD555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71CF9A58-7CF5-4545-A9BD-5372C5EC9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523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B0A21BA9-6AF1-4D58-94B1-61FA650D2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716DC1E1-9F69-438D-A92F-008028CAE0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61AA31D6-BE40-4900-9BED-8012C2CA9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D24D3EC3-557E-40A2-8980-CB2FA9E14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76879E2A-11CA-4377-92D4-FEBEA88BB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90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xmlns="" id="{04215E36-C3E2-4388-8C52-5A984C9093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945532DF-1305-4887-8735-7DE221CB31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B2881B26-B109-4D51-81D6-A594D72D6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3418ABC0-693C-4E50-93BA-FDF23C2C3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7CF45AFA-9919-4304-B864-F5BDAD551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546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9155A93F-C06D-47D8-BF78-7CD3007C9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326F4BDA-835D-4C1E-86A5-97AA0023A6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5D9BE764-2FF4-471B-B41C-088795486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DEF09355-7BED-40B1-98D3-2E67BAE6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FE8C410E-3CD8-441F-8D75-A3ACB530D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201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D04456B1-A9A2-4B48-8FFE-787C90EB8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889DB4F9-78B5-4E99-BE6F-FC95D8409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06FAFB94-0E86-4769-B862-A12BE7C39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3010192F-79CD-4809-A1E5-3A3F85A29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ED5F65D5-83E8-469D-9BE6-1A9458AA9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589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25C9778B-9568-4CCF-A1D8-4F7BF1BE5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D47CD906-F8A0-46A1-8218-28375B71E7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6EF4CCA4-6FB7-4E84-AD21-AE1BF34277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0CEEB356-D850-4D65-848F-4A12A3BE0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084B3F87-3F0C-4E5B-A4AC-8177B6B7A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768F5AC5-36E3-4708-949D-7FAD1AE36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13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A26D8E07-D7D4-4DD6-ADEF-FC07139EB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68581F73-8B97-449A-91DA-2D1AF14CE1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D59075B1-9543-4DA3-BB8A-5F60D950C0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xmlns="" id="{8ADE1946-5607-4562-BFD2-325D594FE1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xmlns="" id="{C3B9BF6A-57AB-4198-A408-AF7F225FE0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xmlns="" id="{336C0F77-92D3-4953-B6D1-16A15865E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xmlns="" id="{082809BD-A1E3-427D-9E80-102AFAC2C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xmlns="" id="{83B83033-0C14-4E2F-BC99-DFA3B1559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57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0028D788-2227-4B03-844D-D75AB700C5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xmlns="" id="{E386290E-B418-4C83-83A9-B05C3D1BE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xmlns="" id="{EAC16C49-C7E4-4AC3-8AD9-D20C09A1A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xmlns="" id="{596F5C67-4878-4917-81B4-3F267598F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984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xmlns="" id="{DBF0D768-4E19-4B6A-8CBC-F19EF5FC8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xmlns="" id="{3CF29E2C-6C29-485E-8E92-8B9FF1333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xmlns="" id="{235EEBCD-0692-45FC-903C-D63EF54FB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321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3E1E1AA0-5EE3-4D2E-AB6A-C2E676B9C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3405C997-D8CE-490A-8808-ED14756EC3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3C53F8E4-A975-4D52-B091-E1E50583A2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C96059A0-2578-48FD-9C50-2C3AF40CB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E0D774FB-8B51-45E0-B088-D17C3C083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03F11A7D-8BFD-4FE1-929A-22A8C1005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10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3B191CEB-FD66-495D-A341-348EFDDB1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xmlns="" id="{CEC9DB25-9B43-4B44-83FE-6EB5CEAF5D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810842F4-4327-4608-AC58-E8908A8CAD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E9D01EAD-A67C-415A-9167-79B9B9636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2F36D7A8-674B-48D7-9B1D-3E0B91BF9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A8902C96-EC4D-445C-989A-989512A42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605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xmlns="" id="{EC8A98CC-0648-499F-8D0C-A53FDE156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8A078DF0-8DC3-4764-9E36-AABD522584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377A4D7E-B10A-4957-9949-DA2F23701D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E6F2A-FE7B-4004-A352-006D59F5AC7D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14B58B37-A782-4D32-83B1-5306A53448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E5A8FDA1-8DA5-461C-9DC2-254DEB9BBD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E234-AF80-41D2-8C3B-4ABA2F1441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62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a 10"/>
          <p:cNvGrpSpPr/>
          <p:nvPr/>
        </p:nvGrpSpPr>
        <p:grpSpPr>
          <a:xfrm>
            <a:off x="1470607" y="1890569"/>
            <a:ext cx="8729802" cy="4239740"/>
            <a:chOff x="1460216" y="789132"/>
            <a:chExt cx="8729802" cy="4239740"/>
          </a:xfrm>
        </p:grpSpPr>
        <p:grpSp>
          <p:nvGrpSpPr>
            <p:cNvPr id="2" name="Grupa 1"/>
            <p:cNvGrpSpPr/>
            <p:nvPr/>
          </p:nvGrpSpPr>
          <p:grpSpPr>
            <a:xfrm>
              <a:off x="1460216" y="789132"/>
              <a:ext cx="4306739" cy="4239740"/>
              <a:chOff x="1470607" y="872260"/>
              <a:chExt cx="4306739" cy="4239740"/>
            </a:xfrm>
          </p:grpSpPr>
          <p:pic>
            <p:nvPicPr>
              <p:cNvPr id="3" name="Obraz 2">
                <a:extLst>
                  <a:ext uri="{FF2B5EF4-FFF2-40B4-BE49-F238E27FC236}">
                    <a16:creationId xmlns:a16="http://schemas.microsoft.com/office/drawing/2014/main" xmlns="" id="{21CFD05E-5BE4-4E8D-915A-4B41473259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65" b="468"/>
              <a:stretch/>
            </p:blipFill>
            <p:spPr>
              <a:xfrm>
                <a:off x="2571625" y="2909284"/>
                <a:ext cx="3205721" cy="2202716"/>
              </a:xfrm>
              <a:prstGeom prst="rect">
                <a:avLst/>
              </a:prstGeom>
            </p:spPr>
          </p:pic>
          <p:sp>
            <p:nvSpPr>
              <p:cNvPr id="4" name="pole tekstowe 3">
                <a:extLst>
                  <a:ext uri="{FF2B5EF4-FFF2-40B4-BE49-F238E27FC236}">
                    <a16:creationId xmlns:a16="http://schemas.microsoft.com/office/drawing/2014/main" xmlns="" id="{494DB2F3-9923-413A-852F-2F75B10155F7}"/>
                  </a:ext>
                </a:extLst>
              </p:cNvPr>
              <p:cNvSpPr txBox="1"/>
              <p:nvPr/>
            </p:nvSpPr>
            <p:spPr>
              <a:xfrm>
                <a:off x="3204344" y="903037"/>
                <a:ext cx="5036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" name="Obraz 7">
                <a:extLst>
                  <a:ext uri="{FF2B5EF4-FFF2-40B4-BE49-F238E27FC236}">
                    <a16:creationId xmlns:a16="http://schemas.microsoft.com/office/drawing/2014/main" xmlns="" id="{5648F1E5-4153-43D7-8165-1BE68D9AD0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colorTemperature colorTemp="7488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3" t="1" r="44543" b="20407"/>
              <a:stretch/>
            </p:blipFill>
            <p:spPr>
              <a:xfrm>
                <a:off x="4158924" y="1274859"/>
                <a:ext cx="1618422" cy="1539603"/>
              </a:xfrm>
              <a:prstGeom prst="rect">
                <a:avLst/>
              </a:prstGeom>
            </p:spPr>
          </p:pic>
          <p:pic>
            <p:nvPicPr>
              <p:cNvPr id="12" name="Obraz 11">
                <a:extLst>
                  <a:ext uri="{FF2B5EF4-FFF2-40B4-BE49-F238E27FC236}">
                    <a16:creationId xmlns:a16="http://schemas.microsoft.com/office/drawing/2014/main" xmlns="" id="{F44B737D-A5E3-45E7-9BBD-6FC4B8A91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colorTemperature colorTemp="4900"/>
                        </a14:imgEffect>
                        <a14:imgEffect>
                          <a14:saturation sat="12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73" r="4894"/>
              <a:stretch/>
            </p:blipFill>
            <p:spPr>
              <a:xfrm>
                <a:off x="2571626" y="1274859"/>
                <a:ext cx="1587297" cy="1539603"/>
              </a:xfrm>
              <a:prstGeom prst="rect">
                <a:avLst/>
              </a:prstGeom>
            </p:spPr>
          </p:pic>
          <p:sp>
            <p:nvSpPr>
              <p:cNvPr id="19" name="pole tekstowe 18">
                <a:extLst>
                  <a:ext uri="{FF2B5EF4-FFF2-40B4-BE49-F238E27FC236}">
                    <a16:creationId xmlns:a16="http://schemas.microsoft.com/office/drawing/2014/main" xmlns="" id="{413A8603-E879-4AA2-9BE0-A590CC9E92FA}"/>
                  </a:ext>
                </a:extLst>
              </p:cNvPr>
              <p:cNvSpPr txBox="1"/>
              <p:nvPr/>
            </p:nvSpPr>
            <p:spPr>
              <a:xfrm>
                <a:off x="1820062" y="1886554"/>
                <a:ext cx="7328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pole tekstowe 19">
                <a:extLst>
                  <a:ext uri="{FF2B5EF4-FFF2-40B4-BE49-F238E27FC236}">
                    <a16:creationId xmlns:a16="http://schemas.microsoft.com/office/drawing/2014/main" xmlns="" id="{05C2A80D-276D-4E4F-B9E6-D962DBB35858}"/>
                  </a:ext>
                </a:extLst>
              </p:cNvPr>
              <p:cNvSpPr txBox="1"/>
              <p:nvPr/>
            </p:nvSpPr>
            <p:spPr>
              <a:xfrm>
                <a:off x="4319073" y="872260"/>
                <a:ext cx="9733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4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nac08hb6</a:t>
                </a:r>
                <a:endParaRPr lang="en-US" sz="14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pole tekstowe 21">
                <a:extLst>
                  <a:ext uri="{FF2B5EF4-FFF2-40B4-BE49-F238E27FC236}">
                    <a16:creationId xmlns:a16="http://schemas.microsoft.com/office/drawing/2014/main" xmlns="" id="{8B9EDDDF-8B58-4FA5-8A94-59F58D2D1895}"/>
                  </a:ext>
                </a:extLst>
              </p:cNvPr>
              <p:cNvSpPr txBox="1"/>
              <p:nvPr/>
            </p:nvSpPr>
            <p:spPr>
              <a:xfrm>
                <a:off x="1470607" y="3816272"/>
                <a:ext cx="108234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l-PL" sz="14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hydration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0" name="Obraz 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60860" y="1803426"/>
              <a:ext cx="3729158" cy="2237495"/>
            </a:xfrm>
            <a:prstGeom prst="rect">
              <a:avLst/>
            </a:prstGeom>
            <a:ln w="12700">
              <a:solidFill>
                <a:schemeClr val="bg1">
                  <a:lumMod val="65000"/>
                </a:schemeClr>
              </a:solidFill>
            </a:ln>
          </p:spPr>
        </p:pic>
      </p:grpSp>
      <p:sp>
        <p:nvSpPr>
          <p:cNvPr id="5" name="TextBox 4"/>
          <p:cNvSpPr txBox="1"/>
          <p:nvPr/>
        </p:nvSpPr>
        <p:spPr>
          <a:xfrm>
            <a:off x="72737" y="67313"/>
            <a:ext cx="1140921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4. Loss of </a:t>
            </a:r>
            <a:r>
              <a:rPr lang="en-US" i="1" dirty="0"/>
              <a:t>BnaC08HB6</a:t>
            </a:r>
            <a:r>
              <a:rPr lang="en-US" dirty="0"/>
              <a:t> function enhances plant sensitivity to dehydration. Left: Phenotypic characterization of three-week old WT and </a:t>
            </a:r>
            <a:r>
              <a:rPr lang="en-US" i="1" dirty="0"/>
              <a:t>bnac08hb6</a:t>
            </a:r>
            <a:r>
              <a:rPr lang="en-US" dirty="0"/>
              <a:t> mutants under control conditions and dehydration. For dehydration, the seedlings were placed in medium containing 15% PEG8000 for 12 hours. Right: Measurements of Relative Water Content (RWC) of harvested leaves from WT and bnac08hb6 plants after 24 hours of dehydration. Data are means (±SD) of ten biological replicat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880132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8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N.Żyła</dc:creator>
  <cp:lastModifiedBy>Lakshmi S</cp:lastModifiedBy>
  <cp:revision>12</cp:revision>
  <dcterms:created xsi:type="dcterms:W3CDTF">2023-08-24T07:41:23Z</dcterms:created>
  <dcterms:modified xsi:type="dcterms:W3CDTF">2024-05-09T06:51:09Z</dcterms:modified>
</cp:coreProperties>
</file>